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7235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26" autoAdjust="0"/>
    <p:restoredTop sz="94660"/>
  </p:normalViewPr>
  <p:slideViewPr>
    <p:cSldViewPr snapToGrid="0">
      <p:cViewPr varScale="1">
        <p:scale>
          <a:sx n="61" d="100"/>
          <a:sy n="61" d="100"/>
        </p:scale>
        <p:origin x="122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h&#232;se\PRATIQUE\Papier%20tt\Statistiques_V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h&#232;se\PRATIQUE\Papier%20tt\Statistiques_V0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h&#232;se\PRATIQUE\Papier%20tt\Statistiques_V02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th&#232;se\PRATIQUE\Papier%20tt\Statistiques_V0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 dirty="0"/>
              <a:t>Tap water and well water</a:t>
            </a:r>
          </a:p>
        </c:rich>
      </c:tx>
      <c:layout>
        <c:manualLayout>
          <c:xMode val="edge"/>
          <c:yMode val="edge"/>
          <c:x val="0.35694996978547688"/>
          <c:y val="2.995647381639074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A$45:$A$58</c:f>
              <c:strCache>
                <c:ptCount val="14"/>
                <c:pt idx="0">
                  <c:v>Pseudomonas aeruginosa</c:v>
                </c:pt>
                <c:pt idx="1">
                  <c:v>Enterobacter spp. </c:v>
                </c:pt>
                <c:pt idx="2">
                  <c:v>Pseudomonas spp.</c:v>
                </c:pt>
                <c:pt idx="3">
                  <c:v>Klebsiella spp.</c:v>
                </c:pt>
                <c:pt idx="4">
                  <c:v>Aeromonas spp.</c:v>
                </c:pt>
                <c:pt idx="5">
                  <c:v>Acinetobacter spp.</c:v>
                </c:pt>
                <c:pt idx="6">
                  <c:v>Stenotrophomonas maltophilia</c:v>
                </c:pt>
                <c:pt idx="7">
                  <c:v>Escherichia coli</c:v>
                </c:pt>
                <c:pt idx="8">
                  <c:v>Citrobacter spp.</c:v>
                </c:pt>
                <c:pt idx="9">
                  <c:v>Leclercia adecarboxylata</c:v>
                </c:pt>
                <c:pt idx="10">
                  <c:v>Unidentified </c:v>
                </c:pt>
                <c:pt idx="11">
                  <c:v>Cronobacter sp. </c:v>
                </c:pt>
                <c:pt idx="12">
                  <c:v>Comamonas aquatica</c:v>
                </c:pt>
                <c:pt idx="13">
                  <c:v>Cupriavidus gilardii</c:v>
                </c:pt>
              </c:strCache>
            </c:strRef>
          </c:cat>
          <c:val>
            <c:numRef>
              <c:f>Feuil3!$B$45:$B$58</c:f>
              <c:numCache>
                <c:formatCode>General</c:formatCode>
                <c:ptCount val="14"/>
                <c:pt idx="0">
                  <c:v>119</c:v>
                </c:pt>
                <c:pt idx="1">
                  <c:v>59</c:v>
                </c:pt>
                <c:pt idx="2">
                  <c:v>51</c:v>
                </c:pt>
                <c:pt idx="3">
                  <c:v>47</c:v>
                </c:pt>
                <c:pt idx="4">
                  <c:v>19</c:v>
                </c:pt>
                <c:pt idx="5">
                  <c:v>14</c:v>
                </c:pt>
                <c:pt idx="6">
                  <c:v>11</c:v>
                </c:pt>
                <c:pt idx="7">
                  <c:v>10</c:v>
                </c:pt>
                <c:pt idx="8">
                  <c:v>7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46-4CDD-A8F6-DF368ADED5AE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505923368"/>
        <c:axId val="505915824"/>
      </c:barChart>
      <c:catAx>
        <c:axId val="5059233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/>
                  <a:t>Genera/Spec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05915824"/>
        <c:crosses val="autoZero"/>
        <c:auto val="1"/>
        <c:lblAlgn val="ctr"/>
        <c:lblOffset val="100"/>
        <c:noMultiLvlLbl val="0"/>
      </c:catAx>
      <c:valAx>
        <c:axId val="5059158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05923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/>
              <a:t>Wastewate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fr-FR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A$26:$A$39</c:f>
              <c:strCache>
                <c:ptCount val="14"/>
                <c:pt idx="0">
                  <c:v>Escherichia coli</c:v>
                </c:pt>
                <c:pt idx="1">
                  <c:v>Citrobacter spp.</c:v>
                </c:pt>
                <c:pt idx="2">
                  <c:v>Klebsiella spp.</c:v>
                </c:pt>
                <c:pt idx="3">
                  <c:v>Pseudomonas spp.</c:v>
                </c:pt>
                <c:pt idx="4">
                  <c:v>Enterobacter spp. </c:v>
                </c:pt>
                <c:pt idx="5">
                  <c:v>Aeromonas spp.</c:v>
                </c:pt>
                <c:pt idx="6">
                  <c:v>Shewanella putrefaciens </c:v>
                </c:pt>
                <c:pt idx="7">
                  <c:v>Providencia rettgeri</c:v>
                </c:pt>
                <c:pt idx="8">
                  <c:v>Leclercia adecarboxylata</c:v>
                </c:pt>
                <c:pt idx="9">
                  <c:v>Comamonas spp.</c:v>
                </c:pt>
                <c:pt idx="10">
                  <c:v>Kluyvera intermedia</c:v>
                </c:pt>
                <c:pt idx="11">
                  <c:v>Raoultella ornithinolytica</c:v>
                </c:pt>
                <c:pt idx="12">
                  <c:v>Acinetobacter baumannii</c:v>
                </c:pt>
                <c:pt idx="13">
                  <c:v>Lelliottia amnigena</c:v>
                </c:pt>
              </c:strCache>
            </c:strRef>
          </c:cat>
          <c:val>
            <c:numRef>
              <c:f>Feuil3!$B$26:$B$39</c:f>
              <c:numCache>
                <c:formatCode>General</c:formatCode>
                <c:ptCount val="14"/>
                <c:pt idx="0">
                  <c:v>22</c:v>
                </c:pt>
                <c:pt idx="1">
                  <c:v>20</c:v>
                </c:pt>
                <c:pt idx="2">
                  <c:v>18</c:v>
                </c:pt>
                <c:pt idx="3">
                  <c:v>12</c:v>
                </c:pt>
                <c:pt idx="4">
                  <c:v>7</c:v>
                </c:pt>
                <c:pt idx="5">
                  <c:v>6</c:v>
                </c:pt>
                <c:pt idx="6">
                  <c:v>6</c:v>
                </c:pt>
                <c:pt idx="7">
                  <c:v>3</c:v>
                </c:pt>
                <c:pt idx="8">
                  <c:v>2</c:v>
                </c:pt>
                <c:pt idx="9">
                  <c:v>2</c:v>
                </c:pt>
                <c:pt idx="10">
                  <c:v>2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60-4C72-A4C7-0B2273BF2D3C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496321888"/>
        <c:axId val="496319920"/>
      </c:barChart>
      <c:catAx>
        <c:axId val="4963218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050" b="1">
                    <a:solidFill>
                      <a:sysClr val="windowText" lastClr="000000"/>
                    </a:solidFill>
                  </a:rPr>
                  <a:t>Genera/Speci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96319920"/>
        <c:crosses val="autoZero"/>
        <c:auto val="1"/>
        <c:lblAlgn val="ctr"/>
        <c:lblOffset val="100"/>
        <c:noMultiLvlLbl val="0"/>
      </c:catAx>
      <c:valAx>
        <c:axId val="49631992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b="1"/>
                  <a:t>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96321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2741764171536529"/>
          <c:y val="4.7601685992428706E-2"/>
          <c:w val="0.65245372992255168"/>
          <c:h val="0.82251045226712827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Feuil3!$B$95</c:f>
              <c:strCache>
                <c:ptCount val="1"/>
                <c:pt idx="0">
                  <c:v>Enterobacteria</c:v>
                </c:pt>
              </c:strCache>
            </c:strRef>
          </c:tx>
          <c:spPr>
            <a:pattFill prst="lt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-2.2522522522522522E-3"/>
                  <c:y val="-3.256996933421981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BC60-49E6-92F8-4239FD43024F}"/>
                </c:ext>
              </c:extLst>
            </c:dLbl>
            <c:dLbl>
              <c:idx val="1"/>
              <c:layout>
                <c:manualLayout>
                  <c:x val="-4.1290814296281058E-17"/>
                  <c:y val="-2.44274770006648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C60-49E6-92F8-4239FD43024F}"/>
                </c:ext>
              </c:extLst>
            </c:dLbl>
            <c:dLbl>
              <c:idx val="2"/>
              <c:layout>
                <c:manualLayout>
                  <c:x val="0"/>
                  <c:y val="-1.628498466710990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BC60-49E6-92F8-4239FD43024F}"/>
                </c:ext>
              </c:extLst>
            </c:dLbl>
            <c:dLbl>
              <c:idx val="3"/>
              <c:layout>
                <c:manualLayout>
                  <c:x val="0"/>
                  <c:y val="-2.442747700066493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C60-49E6-92F8-4239FD43024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A$96:$A$99</c:f>
              <c:strCache>
                <c:ptCount val="4"/>
                <c:pt idx="0">
                  <c:v>MH</c:v>
                </c:pt>
                <c:pt idx="1">
                  <c:v>CH</c:v>
                </c:pt>
                <c:pt idx="2">
                  <c:v>PH</c:v>
                </c:pt>
                <c:pt idx="3">
                  <c:v>UH</c:v>
                </c:pt>
              </c:strCache>
            </c:strRef>
          </c:cat>
          <c:val>
            <c:numRef>
              <c:f>Feuil3!$B$96:$B$99</c:f>
              <c:numCache>
                <c:formatCode>General</c:formatCode>
                <c:ptCount val="4"/>
                <c:pt idx="0">
                  <c:v>76</c:v>
                </c:pt>
                <c:pt idx="1">
                  <c:v>43</c:v>
                </c:pt>
                <c:pt idx="2">
                  <c:v>5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C60-49E6-92F8-4239FD43024F}"/>
            </c:ext>
          </c:extLst>
        </c:ser>
        <c:ser>
          <c:idx val="1"/>
          <c:order val="1"/>
          <c:tx>
            <c:strRef>
              <c:f>Feuil3!$C$95</c:f>
              <c:strCache>
                <c:ptCount val="1"/>
                <c:pt idx="0">
                  <c:v>Gnf-GNB</c:v>
                </c:pt>
              </c:strCache>
            </c:strRef>
          </c:tx>
          <c:spPr>
            <a:pattFill prst="lgCheck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6.7567567567567571E-3"/>
                  <c:y val="-3.256996933421981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C60-49E6-92F8-4239FD43024F}"/>
                </c:ext>
              </c:extLst>
            </c:dLbl>
            <c:dLbl>
              <c:idx val="1"/>
              <c:layout>
                <c:manualLayout>
                  <c:x val="0"/>
                  <c:y val="-3.256996933421981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BC60-49E6-92F8-4239FD43024F}"/>
                </c:ext>
              </c:extLst>
            </c:dLbl>
            <c:dLbl>
              <c:idx val="2"/>
              <c:layout>
                <c:manualLayout>
                  <c:x val="0"/>
                  <c:y val="-2.44274770006648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C60-49E6-92F8-4239FD43024F}"/>
                </c:ext>
              </c:extLst>
            </c:dLbl>
            <c:dLbl>
              <c:idx val="3"/>
              <c:layout>
                <c:manualLayout>
                  <c:x val="0"/>
                  <c:y val="-3.664121550099729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BC60-49E6-92F8-4239FD43024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A$96:$A$99</c:f>
              <c:strCache>
                <c:ptCount val="4"/>
                <c:pt idx="0">
                  <c:v>MH</c:v>
                </c:pt>
                <c:pt idx="1">
                  <c:v>CH</c:v>
                </c:pt>
                <c:pt idx="2">
                  <c:v>PH</c:v>
                </c:pt>
                <c:pt idx="3">
                  <c:v>UH</c:v>
                </c:pt>
              </c:strCache>
            </c:strRef>
          </c:cat>
          <c:val>
            <c:numRef>
              <c:f>Feuil3!$C$96:$C$99</c:f>
              <c:numCache>
                <c:formatCode>General</c:formatCode>
                <c:ptCount val="4"/>
                <c:pt idx="0">
                  <c:v>83</c:v>
                </c:pt>
                <c:pt idx="1">
                  <c:v>92</c:v>
                </c:pt>
                <c:pt idx="2">
                  <c:v>20</c:v>
                </c:pt>
                <c:pt idx="3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BC60-49E6-92F8-4239FD43024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549313136"/>
        <c:axId val="549311496"/>
        <c:axId val="551139296"/>
      </c:bar3DChart>
      <c:catAx>
        <c:axId val="5493131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/>
                  <a:t>Hospital</a:t>
                </a:r>
              </a:p>
            </c:rich>
          </c:tx>
          <c:layout>
            <c:manualLayout>
              <c:xMode val="edge"/>
              <c:yMode val="edge"/>
              <c:x val="0.35016680698507729"/>
              <c:y val="0.882534469062189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49311496"/>
        <c:crosses val="autoZero"/>
        <c:auto val="1"/>
        <c:lblAlgn val="ctr"/>
        <c:lblOffset val="100"/>
        <c:noMultiLvlLbl val="0"/>
      </c:catAx>
      <c:valAx>
        <c:axId val="549311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/>
                  <a:t>Number of strain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49313136"/>
        <c:crosses val="autoZero"/>
        <c:crossBetween val="between"/>
      </c:valAx>
      <c:serAx>
        <c:axId val="55113929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549311496"/>
        <c:crosses val="autoZero"/>
      </c:ser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12700">
      <a:solidFill>
        <a:schemeClr val="tx1"/>
      </a:solidFill>
    </a:ln>
    <a:effectLst/>
  </c:spPr>
  <c:txPr>
    <a:bodyPr/>
    <a:lstStyle/>
    <a:p>
      <a:pPr>
        <a:defRPr sz="1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standard"/>
        <c:varyColors val="0"/>
        <c:ser>
          <c:idx val="0"/>
          <c:order val="0"/>
          <c:tx>
            <c:strRef>
              <c:f>Feuil3!$A$3</c:f>
              <c:strCache>
                <c:ptCount val="1"/>
                <c:pt idx="0">
                  <c:v>Enterobacteria</c:v>
                </c:pt>
              </c:strCache>
            </c:strRef>
          </c:tx>
          <c:spPr>
            <a:pattFill prst="wdDnDiag">
              <a:fgClr>
                <a:schemeClr val="bg2">
                  <a:lumMod val="75000"/>
                </a:schemeClr>
              </a:fgClr>
              <a:bgClr>
                <a:schemeClr val="bg1"/>
              </a:bgClr>
            </a:patt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-2.5462668816039986E-17"/>
                  <c:y val="-6.481481481481489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B7E-491A-85F2-D73C5A9D0ABE}"/>
                </c:ext>
              </c:extLst>
            </c:dLbl>
            <c:dLbl>
              <c:idx val="1"/>
              <c:layout>
                <c:manualLayout>
                  <c:x val="-5.0925337632079971E-17"/>
                  <c:y val="-6.944444444444453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B7E-491A-85F2-D73C5A9D0AB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2:$C$2</c:f>
              <c:strCache>
                <c:ptCount val="2"/>
                <c:pt idx="0">
                  <c:v>Wastewater</c:v>
                </c:pt>
                <c:pt idx="1">
                  <c:v>Tap water and well water </c:v>
                </c:pt>
              </c:strCache>
            </c:strRef>
          </c:cat>
          <c:val>
            <c:numRef>
              <c:f>Feuil3!$B$3:$C$3</c:f>
              <c:numCache>
                <c:formatCode>General</c:formatCode>
                <c:ptCount val="2"/>
                <c:pt idx="0">
                  <c:v>76</c:v>
                </c:pt>
                <c:pt idx="1">
                  <c:v>1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B7E-491A-85F2-D73C5A9D0ABE}"/>
            </c:ext>
          </c:extLst>
        </c:ser>
        <c:ser>
          <c:idx val="1"/>
          <c:order val="1"/>
          <c:tx>
            <c:strRef>
              <c:f>Feuil3!$A$4</c:f>
              <c:strCache>
                <c:ptCount val="1"/>
                <c:pt idx="0">
                  <c:v>Gnf-GNB</c:v>
                </c:pt>
              </c:strCache>
            </c:strRef>
          </c:tx>
          <c:spPr>
            <a:pattFill prst="lgCheck">
              <a:fgClr>
                <a:schemeClr val="bg2">
                  <a:lumMod val="75000"/>
                </a:schemeClr>
              </a:fgClr>
              <a:bgClr>
                <a:schemeClr val="bg1"/>
              </a:bgClr>
            </a:pattFill>
            <a:ln>
              <a:noFill/>
            </a:ln>
            <a:effectLst/>
            <a:sp3d/>
          </c:spPr>
          <c:invertIfNegative val="0"/>
          <c:dLbls>
            <c:dLbl>
              <c:idx val="0"/>
              <c:layout>
                <c:manualLayout>
                  <c:x val="0"/>
                  <c:y val="-7.407407407407415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B7E-491A-85F2-D73C5A9D0ABE}"/>
                </c:ext>
              </c:extLst>
            </c:dLbl>
            <c:dLbl>
              <c:idx val="1"/>
              <c:layout>
                <c:manualLayout>
                  <c:x val="8.3333333333333332E-3"/>
                  <c:y val="-3.703703703703701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CB7E-491A-85F2-D73C5A9D0AB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fr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euil3!$B$2:$C$2</c:f>
              <c:strCache>
                <c:ptCount val="2"/>
                <c:pt idx="0">
                  <c:v>Wastewater</c:v>
                </c:pt>
                <c:pt idx="1">
                  <c:v>Tap water and well water </c:v>
                </c:pt>
              </c:strCache>
            </c:strRef>
          </c:cat>
          <c:val>
            <c:numRef>
              <c:f>Feuil3!$B$4:$C$4</c:f>
              <c:numCache>
                <c:formatCode>General</c:formatCode>
                <c:ptCount val="2"/>
                <c:pt idx="0">
                  <c:v>27</c:v>
                </c:pt>
                <c:pt idx="1">
                  <c:v>2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B7E-491A-85F2-D73C5A9D0AB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432994632"/>
        <c:axId val="432992336"/>
        <c:axId val="423228920"/>
      </c:bar3DChart>
      <c:catAx>
        <c:axId val="432994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32992336"/>
        <c:crosses val="autoZero"/>
        <c:auto val="1"/>
        <c:lblAlgn val="ctr"/>
        <c:lblOffset val="100"/>
        <c:noMultiLvlLbl val="0"/>
      </c:catAx>
      <c:valAx>
        <c:axId val="4329923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Number of strain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32994632"/>
        <c:crosses val="autoZero"/>
        <c:crossBetween val="between"/>
      </c:valAx>
      <c:serAx>
        <c:axId val="42322892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432992336"/>
        <c:crosses val="autoZero"/>
      </c:ser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latin typeface="Times New Roman" panose="02020603050405020304" pitchFamily="18" charset="0"/>
          <a:cs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99808</cdr:x>
      <cdr:y>1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414D10F0-5BCA-44CE-8481-F73CEA6B5128}"/>
            </a:ext>
          </a:extLst>
        </cdr:cNvPr>
        <cdr:cNvSpPr/>
      </cdr:nvSpPr>
      <cdr:spPr>
        <a:xfrm xmlns:a="http://schemas.openxmlformats.org/drawingml/2006/main">
          <a:off x="0" y="-7951"/>
          <a:ext cx="4847474" cy="30821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fr-FR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84197"/>
            <a:ext cx="9144000" cy="2519139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800484"/>
            <a:ext cx="9144000" cy="174698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6351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7861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5241"/>
            <a:ext cx="2628900" cy="613202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5241"/>
            <a:ext cx="7734300" cy="613202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504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9728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803932"/>
            <a:ext cx="10515600" cy="300990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42309"/>
            <a:ext cx="10515600" cy="158283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3029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26204"/>
            <a:ext cx="5181600" cy="459106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26204"/>
            <a:ext cx="5181600" cy="459106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9044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5241"/>
            <a:ext cx="10515600" cy="139859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73783"/>
            <a:ext cx="5157787" cy="86930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43086"/>
            <a:ext cx="5157787" cy="388758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73783"/>
            <a:ext cx="5183188" cy="86930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43086"/>
            <a:ext cx="5183188" cy="388758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0187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0924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1221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2388"/>
            <a:ext cx="3932237" cy="168835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41825"/>
            <a:ext cx="6172200" cy="514212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70748"/>
            <a:ext cx="3932237" cy="402157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9835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2388"/>
            <a:ext cx="3932237" cy="168835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41825"/>
            <a:ext cx="6172200" cy="5142126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70748"/>
            <a:ext cx="3932237" cy="402157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6916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5241"/>
            <a:ext cx="10515600" cy="1398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26204"/>
            <a:ext cx="10515600" cy="4591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706538"/>
            <a:ext cx="2743200" cy="3852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B685B-6EA0-4AC7-B40D-CEA0E0FBB059}" type="datetimeFigureOut">
              <a:rPr lang="fr-FR" smtClean="0"/>
              <a:t>06/04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706538"/>
            <a:ext cx="4114800" cy="3852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706538"/>
            <a:ext cx="2743200" cy="3852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275EE-5681-4664-A8AA-B89492F0EB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9615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EE790617-D3E2-4A33-9D43-770A4545B09F}"/>
              </a:ext>
            </a:extLst>
          </p:cNvPr>
          <p:cNvGrpSpPr/>
          <p:nvPr/>
        </p:nvGrpSpPr>
        <p:grpSpPr>
          <a:xfrm>
            <a:off x="336884" y="175914"/>
            <a:ext cx="11518232" cy="6545179"/>
            <a:chOff x="336884" y="349334"/>
            <a:chExt cx="11518232" cy="6545179"/>
          </a:xfrm>
        </p:grpSpPr>
        <p:grpSp>
          <p:nvGrpSpPr>
            <p:cNvPr id="38" name="Groupe 37">
              <a:extLst>
                <a:ext uri="{FF2B5EF4-FFF2-40B4-BE49-F238E27FC236}">
                  <a16:creationId xmlns:a16="http://schemas.microsoft.com/office/drawing/2014/main" id="{B3413ECC-BF7E-4A5D-A83D-DFCED5A67C99}"/>
                </a:ext>
              </a:extLst>
            </p:cNvPr>
            <p:cNvGrpSpPr/>
            <p:nvPr/>
          </p:nvGrpSpPr>
          <p:grpSpPr>
            <a:xfrm>
              <a:off x="336884" y="349334"/>
              <a:ext cx="11518232" cy="6545179"/>
              <a:chOff x="336884" y="160421"/>
              <a:chExt cx="11518232" cy="6545179"/>
            </a:xfrm>
          </p:grpSpPr>
          <p:grpSp>
            <p:nvGrpSpPr>
              <p:cNvPr id="13" name="Groupe 12">
                <a:extLst>
                  <a:ext uri="{FF2B5EF4-FFF2-40B4-BE49-F238E27FC236}">
                    <a16:creationId xmlns:a16="http://schemas.microsoft.com/office/drawing/2014/main" id="{2298AEE0-8695-4F4A-8B40-7B383BA24784}"/>
                  </a:ext>
                </a:extLst>
              </p:cNvPr>
              <p:cNvGrpSpPr/>
              <p:nvPr/>
            </p:nvGrpSpPr>
            <p:grpSpPr>
              <a:xfrm>
                <a:off x="5540554" y="322274"/>
                <a:ext cx="6148237" cy="3055547"/>
                <a:chOff x="295044" y="2778034"/>
                <a:chExt cx="6267912" cy="3143795"/>
              </a:xfrm>
            </p:grpSpPr>
            <p:graphicFrame>
              <p:nvGraphicFramePr>
                <p:cNvPr id="14" name="Graphique 13">
                  <a:extLst>
                    <a:ext uri="{FF2B5EF4-FFF2-40B4-BE49-F238E27FC236}">
                      <a16:creationId xmlns:a16="http://schemas.microsoft.com/office/drawing/2014/main" id="{4D122B4F-3736-4302-BAF3-F119533527DE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64621799"/>
                    </p:ext>
                  </p:extLst>
                </p:nvPr>
              </p:nvGraphicFramePr>
              <p:xfrm>
                <a:off x="351831" y="2855979"/>
                <a:ext cx="6154338" cy="305334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F302B0FC-22B8-496E-B115-8AB71A7827B8}"/>
                    </a:ext>
                  </a:extLst>
                </p:cNvPr>
                <p:cNvSpPr/>
                <p:nvPr/>
              </p:nvSpPr>
              <p:spPr>
                <a:xfrm>
                  <a:off x="295044" y="2778034"/>
                  <a:ext cx="6267912" cy="314379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801" dirty="0"/>
                </a:p>
              </p:txBody>
            </p:sp>
          </p:grpSp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B0AEAF9F-8344-43D1-B3E5-C1DFDECFDEB2}"/>
                  </a:ext>
                </a:extLst>
              </p:cNvPr>
              <p:cNvSpPr txBox="1"/>
              <p:nvPr/>
            </p:nvSpPr>
            <p:spPr>
              <a:xfrm>
                <a:off x="5565200" y="338317"/>
                <a:ext cx="4740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C</a:t>
                </a:r>
              </a:p>
            </p:txBody>
          </p:sp>
          <p:grpSp>
            <p:nvGrpSpPr>
              <p:cNvPr id="17" name="Groupe 16">
                <a:extLst>
                  <a:ext uri="{FF2B5EF4-FFF2-40B4-BE49-F238E27FC236}">
                    <a16:creationId xmlns:a16="http://schemas.microsoft.com/office/drawing/2014/main" id="{209F1132-E807-4D65-B83E-9FDE6705E2F0}"/>
                  </a:ext>
                </a:extLst>
              </p:cNvPr>
              <p:cNvGrpSpPr/>
              <p:nvPr/>
            </p:nvGrpSpPr>
            <p:grpSpPr>
              <a:xfrm>
                <a:off x="5540554" y="3464138"/>
                <a:ext cx="6148237" cy="3082148"/>
                <a:chOff x="295044" y="5984327"/>
                <a:chExt cx="6267912" cy="3079930"/>
              </a:xfrm>
            </p:grpSpPr>
            <p:graphicFrame>
              <p:nvGraphicFramePr>
                <p:cNvPr id="18" name="Graphique 17">
                  <a:extLst>
                    <a:ext uri="{FF2B5EF4-FFF2-40B4-BE49-F238E27FC236}">
                      <a16:creationId xmlns:a16="http://schemas.microsoft.com/office/drawing/2014/main" id="{B4153C04-8BB6-4F8A-9EF2-B02F1773D42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169544280"/>
                    </p:ext>
                  </p:extLst>
                </p:nvPr>
              </p:nvGraphicFramePr>
              <p:xfrm>
                <a:off x="295044" y="6096000"/>
                <a:ext cx="6267912" cy="294167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C1678627-AA49-4778-873D-F220158398E1}"/>
                    </a:ext>
                  </a:extLst>
                </p:cNvPr>
                <p:cNvSpPr/>
                <p:nvPr/>
              </p:nvSpPr>
              <p:spPr>
                <a:xfrm>
                  <a:off x="295044" y="5984327"/>
                  <a:ext cx="6267912" cy="307993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801"/>
                </a:p>
              </p:txBody>
            </p:sp>
          </p:grp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D57AE5C2-9505-46BC-AD48-4DDF21EA748A}"/>
                  </a:ext>
                </a:extLst>
              </p:cNvPr>
              <p:cNvSpPr txBox="1"/>
              <p:nvPr/>
            </p:nvSpPr>
            <p:spPr>
              <a:xfrm>
                <a:off x="5596257" y="3489574"/>
                <a:ext cx="4740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D</a:t>
                </a:r>
              </a:p>
            </p:txBody>
          </p:sp>
          <p:graphicFrame>
            <p:nvGraphicFramePr>
              <p:cNvPr id="21" name="Graphique 20">
                <a:extLst>
                  <a:ext uri="{FF2B5EF4-FFF2-40B4-BE49-F238E27FC236}">
                    <a16:creationId xmlns:a16="http://schemas.microsoft.com/office/drawing/2014/main" id="{5745B8E7-D77E-4553-94A9-606C34F6B31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7003270"/>
                  </p:ext>
                </p:extLst>
              </p:nvPr>
            </p:nvGraphicFramePr>
            <p:xfrm>
              <a:off x="485208" y="3467975"/>
              <a:ext cx="4856811" cy="306775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32" name="Groupe 31">
                <a:extLst>
                  <a:ext uri="{FF2B5EF4-FFF2-40B4-BE49-F238E27FC236}">
                    <a16:creationId xmlns:a16="http://schemas.microsoft.com/office/drawing/2014/main" id="{A941925F-55EA-4955-9234-CF373B988CDC}"/>
                  </a:ext>
                </a:extLst>
              </p:cNvPr>
              <p:cNvGrpSpPr/>
              <p:nvPr/>
            </p:nvGrpSpPr>
            <p:grpSpPr>
              <a:xfrm>
                <a:off x="485209" y="322274"/>
                <a:ext cx="4856811" cy="3043396"/>
                <a:chOff x="0" y="0"/>
                <a:chExt cx="5021179" cy="3283646"/>
              </a:xfrm>
            </p:grpSpPr>
            <p:grpSp>
              <p:nvGrpSpPr>
                <p:cNvPr id="30" name="Groupe 29">
                  <a:extLst>
                    <a:ext uri="{FF2B5EF4-FFF2-40B4-BE49-F238E27FC236}">
                      <a16:creationId xmlns:a16="http://schemas.microsoft.com/office/drawing/2014/main" id="{D683F0B0-5061-4CCD-997F-F4528EF9C257}"/>
                    </a:ext>
                  </a:extLst>
                </p:cNvPr>
                <p:cNvGrpSpPr/>
                <p:nvPr/>
              </p:nvGrpSpPr>
              <p:grpSpPr>
                <a:xfrm>
                  <a:off x="0" y="0"/>
                  <a:ext cx="5021179" cy="3283646"/>
                  <a:chOff x="0" y="0"/>
                  <a:chExt cx="5021179" cy="3283646"/>
                </a:xfrm>
              </p:grpSpPr>
              <p:grpSp>
                <p:nvGrpSpPr>
                  <p:cNvPr id="23" name="Groupe 22">
                    <a:extLst>
                      <a:ext uri="{FF2B5EF4-FFF2-40B4-BE49-F238E27FC236}">
                        <a16:creationId xmlns:a16="http://schemas.microsoft.com/office/drawing/2014/main" id="{10FA2E14-4FC3-4AA2-B041-C38D8080EA02}"/>
                      </a:ext>
                    </a:extLst>
                  </p:cNvPr>
                  <p:cNvGrpSpPr/>
                  <p:nvPr/>
                </p:nvGrpSpPr>
                <p:grpSpPr>
                  <a:xfrm>
                    <a:off x="79904" y="81738"/>
                    <a:ext cx="4863795" cy="3111942"/>
                    <a:chOff x="-148695" y="-240536"/>
                    <a:chExt cx="4863795" cy="3111942"/>
                  </a:xfrm>
                </p:grpSpPr>
                <p:graphicFrame>
                  <p:nvGraphicFramePr>
                    <p:cNvPr id="24" name="Graphique 23">
                      <a:extLst>
                        <a:ext uri="{FF2B5EF4-FFF2-40B4-BE49-F238E27FC236}">
                          <a16:creationId xmlns:a16="http://schemas.microsoft.com/office/drawing/2014/main" id="{CFB5C44D-7BBE-4427-89B8-4BF0694CF294}"/>
                        </a:ext>
                      </a:extLst>
                    </p:cNvPr>
                    <p:cNvGraphicFramePr/>
                    <p:nvPr>
                      <p:extLst>
                        <p:ext uri="{D42A27DB-BD31-4B8C-83A1-F6EECF244321}">
                          <p14:modId xmlns:p14="http://schemas.microsoft.com/office/powerpoint/2010/main" val="382798029"/>
                        </p:ext>
                      </p:extLst>
                    </p:nvPr>
                  </p:nvGraphicFramePr>
                  <p:xfrm>
                    <a:off x="-148695" y="-240536"/>
                    <a:ext cx="4863795" cy="3111942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5"/>
                    </a:graphicData>
                  </a:graphic>
                </p:graphicFrame>
                <p:sp>
                  <p:nvSpPr>
                    <p:cNvPr id="25" name="Accolade ouvrante 24">
                      <a:extLst>
                        <a:ext uri="{FF2B5EF4-FFF2-40B4-BE49-F238E27FC236}">
                          <a16:creationId xmlns:a16="http://schemas.microsoft.com/office/drawing/2014/main" id="{95C32C2B-A354-4215-814F-66260185223C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1376581" y="1031190"/>
                      <a:ext cx="161925" cy="390525"/>
                    </a:xfrm>
                    <a:prstGeom prst="leftBrac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t"/>
                    <a:lstStyle>
                      <a:lvl1pPr marL="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l"/>
                      <a:endParaRPr lang="fr-FR"/>
                    </a:p>
                  </p:txBody>
                </p:sp>
                <p:sp>
                  <p:nvSpPr>
                    <p:cNvPr id="26" name="Accolade ouvrante 25">
                      <a:extLst>
                        <a:ext uri="{FF2B5EF4-FFF2-40B4-BE49-F238E27FC236}">
                          <a16:creationId xmlns:a16="http://schemas.microsoft.com/office/drawing/2014/main" id="{2621D973-CDEE-46F7-9495-27CB7E807C99}"/>
                        </a:ext>
                      </a:extLst>
                    </p:cNvPr>
                    <p:cNvSpPr/>
                    <p:nvPr/>
                  </p:nvSpPr>
                  <p:spPr>
                    <a:xfrm rot="1700978">
                      <a:off x="2281974" y="55634"/>
                      <a:ext cx="220061" cy="869807"/>
                    </a:xfrm>
                    <a:prstGeom prst="leftBrac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  <p:txBody>
                    <a:bodyPr rtlCol="0" anchor="t"/>
                    <a:lstStyle>
                      <a:lvl1pPr marL="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l"/>
                      <a:endParaRPr lang="fr-FR"/>
                    </a:p>
                  </p:txBody>
                </p:sp>
                <p:sp>
                  <p:nvSpPr>
                    <p:cNvPr id="27" name="ZoneTexte 4">
                      <a:extLst>
                        <a:ext uri="{FF2B5EF4-FFF2-40B4-BE49-F238E27FC236}">
                          <a16:creationId xmlns:a16="http://schemas.microsoft.com/office/drawing/2014/main" id="{736A2891-EED1-4CDF-AFA8-22119DD2DAA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62535" y="878789"/>
                      <a:ext cx="476250" cy="266700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t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fr-F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</a:t>
                      </a:r>
                    </a:p>
                  </p:txBody>
                </p:sp>
                <p:sp>
                  <p:nvSpPr>
                    <p:cNvPr id="28" name="ZoneTexte 5">
                      <a:extLst>
                        <a:ext uri="{FF2B5EF4-FFF2-40B4-BE49-F238E27FC236}">
                          <a16:creationId xmlns:a16="http://schemas.microsoft.com/office/drawing/2014/main" id="{AE11F24C-5529-4576-AEAA-367149C6FB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25333" y="283563"/>
                      <a:ext cx="476250" cy="266700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dk1"/>
                    </a:fontRef>
                  </p:style>
                  <p:txBody>
                    <a:bodyPr wrap="square" rtlCol="0" anchor="t"/>
                    <a:lstStyle>
                      <a:lvl1pPr marL="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indent="0">
                        <a:defRPr sz="110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r>
                        <a:rPr lang="fr-FR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2</a:t>
                      </a:r>
                    </a:p>
                  </p:txBody>
                </p:sp>
              </p:grpSp>
              <p:sp>
                <p:nvSpPr>
                  <p:cNvPr id="29" name="Rectangle 28">
                    <a:extLst>
                      <a:ext uri="{FF2B5EF4-FFF2-40B4-BE49-F238E27FC236}">
                        <a16:creationId xmlns:a16="http://schemas.microsoft.com/office/drawing/2014/main" id="{88EAC1B1-3C80-483B-BFBA-A373D49FFEFA}"/>
                      </a:ext>
                    </a:extLst>
                  </p:cNvPr>
                  <p:cNvSpPr/>
                  <p:nvPr/>
                </p:nvSpPr>
                <p:spPr>
                  <a:xfrm>
                    <a:off x="0" y="0"/>
                    <a:ext cx="5021179" cy="3283646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sp>
              <p:nvSpPr>
                <p:cNvPr id="31" name="ZoneTexte 30">
                  <a:extLst>
                    <a:ext uri="{FF2B5EF4-FFF2-40B4-BE49-F238E27FC236}">
                      <a16:creationId xmlns:a16="http://schemas.microsoft.com/office/drawing/2014/main" id="{D160DB25-EE30-4A4E-B686-C449336AE89B}"/>
                    </a:ext>
                  </a:extLst>
                </p:cNvPr>
                <p:cNvSpPr txBox="1"/>
                <p:nvPr/>
              </p:nvSpPr>
              <p:spPr>
                <a:xfrm>
                  <a:off x="18609" y="17309"/>
                  <a:ext cx="474098" cy="33207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400" b="1" dirty="0"/>
                    <a:t>A</a:t>
                  </a:r>
                </a:p>
              </p:txBody>
            </p:sp>
          </p:grp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7EB55287-0977-4E00-8857-D5A1D709A4D7}"/>
                  </a:ext>
                </a:extLst>
              </p:cNvPr>
              <p:cNvSpPr txBox="1"/>
              <p:nvPr/>
            </p:nvSpPr>
            <p:spPr>
              <a:xfrm>
                <a:off x="495449" y="3492847"/>
                <a:ext cx="4740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/>
                  <a:t>B</a:t>
                </a: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6BF31560-A9C2-4CBC-9DF7-27472E4E51C4}"/>
                  </a:ext>
                </a:extLst>
              </p:cNvPr>
              <p:cNvSpPr/>
              <p:nvPr/>
            </p:nvSpPr>
            <p:spPr>
              <a:xfrm>
                <a:off x="336884" y="160421"/>
                <a:ext cx="11518232" cy="654517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83604C2F-A55B-4D3A-9A16-EE974962263E}"/>
                </a:ext>
              </a:extLst>
            </p:cNvPr>
            <p:cNvSpPr txBox="1"/>
            <p:nvPr/>
          </p:nvSpPr>
          <p:spPr>
            <a:xfrm>
              <a:off x="1696038" y="3709265"/>
              <a:ext cx="20778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ap</a:t>
              </a:r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ater and </a:t>
              </a:r>
              <a:r>
                <a:rPr lang="fr-FR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ell</a:t>
              </a:r>
              <a:r>
                <a:rPr lang="fr-F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ater </a:t>
              </a:r>
            </a:p>
          </p:txBody>
        </p:sp>
      </p:grpSp>
      <p:sp>
        <p:nvSpPr>
          <p:cNvPr id="34" name="ZoneTexte 33">
            <a:extLst>
              <a:ext uri="{FF2B5EF4-FFF2-40B4-BE49-F238E27FC236}">
                <a16:creationId xmlns:a16="http://schemas.microsoft.com/office/drawing/2014/main" id="{6CDBE7B8-AA0E-4C0F-9B27-2D019BDC5C7A}"/>
              </a:ext>
            </a:extLst>
          </p:cNvPr>
          <p:cNvSpPr txBox="1"/>
          <p:nvPr/>
        </p:nvSpPr>
        <p:spPr>
          <a:xfrm>
            <a:off x="1520607" y="6832846"/>
            <a:ext cx="998677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2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.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dentification results. CH, cancer hospital; ENV, environment; MH, maternity hospital; PH, public hospital; UH, university hospital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20434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75</Words>
  <Application>Microsoft Office PowerPoint</Application>
  <PresentationFormat>Personnalisé</PresentationFormat>
  <Paragraphs>2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p</dc:creator>
  <cp:lastModifiedBy>hp</cp:lastModifiedBy>
  <cp:revision>16</cp:revision>
  <dcterms:created xsi:type="dcterms:W3CDTF">2021-07-24T17:49:21Z</dcterms:created>
  <dcterms:modified xsi:type="dcterms:W3CDTF">2022-04-05T22:03:35Z</dcterms:modified>
</cp:coreProperties>
</file>